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48" d="100"/>
          <a:sy n="48" d="100"/>
        </p:scale>
        <p:origin x="230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D7A80-27B7-4BC2-AA0B-1FF4A2A80187}" type="datetimeFigureOut">
              <a:rPr lang="es-ES" smtClean="0"/>
              <a:t>29/06/2017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69D7-F050-4ACD-8F9A-B132B5ECE3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09335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D7A80-27B7-4BC2-AA0B-1FF4A2A80187}" type="datetimeFigureOut">
              <a:rPr lang="es-ES" smtClean="0"/>
              <a:t>29/06/2017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69D7-F050-4ACD-8F9A-B132B5ECE3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43553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D7A80-27B7-4BC2-AA0B-1FF4A2A80187}" type="datetimeFigureOut">
              <a:rPr lang="es-ES" smtClean="0"/>
              <a:t>29/06/2017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69D7-F050-4ACD-8F9A-B132B5ECE3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5600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D7A80-27B7-4BC2-AA0B-1FF4A2A80187}" type="datetimeFigureOut">
              <a:rPr lang="es-ES" smtClean="0"/>
              <a:t>29/06/2017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69D7-F050-4ACD-8F9A-B132B5ECE3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41805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D7A80-27B7-4BC2-AA0B-1FF4A2A80187}" type="datetimeFigureOut">
              <a:rPr lang="es-ES" smtClean="0"/>
              <a:t>29/06/2017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69D7-F050-4ACD-8F9A-B132B5ECE3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740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D7A80-27B7-4BC2-AA0B-1FF4A2A80187}" type="datetimeFigureOut">
              <a:rPr lang="es-ES" smtClean="0"/>
              <a:t>29/06/2017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69D7-F050-4ACD-8F9A-B132B5ECE3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3101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D7A80-27B7-4BC2-AA0B-1FF4A2A80187}" type="datetimeFigureOut">
              <a:rPr lang="es-ES" smtClean="0"/>
              <a:t>29/06/2017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69D7-F050-4ACD-8F9A-B132B5ECE3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63371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D7A80-27B7-4BC2-AA0B-1FF4A2A80187}" type="datetimeFigureOut">
              <a:rPr lang="es-ES" smtClean="0"/>
              <a:t>29/06/2017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69D7-F050-4ACD-8F9A-B132B5ECE3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2666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D7A80-27B7-4BC2-AA0B-1FF4A2A80187}" type="datetimeFigureOut">
              <a:rPr lang="es-ES" smtClean="0"/>
              <a:t>29/06/2017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69D7-F050-4ACD-8F9A-B132B5ECE3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224975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D7A80-27B7-4BC2-AA0B-1FF4A2A80187}" type="datetimeFigureOut">
              <a:rPr lang="es-ES" smtClean="0"/>
              <a:t>29/06/2017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69D7-F050-4ACD-8F9A-B132B5ECE3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7474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D7A80-27B7-4BC2-AA0B-1FF4A2A80187}" type="datetimeFigureOut">
              <a:rPr lang="es-ES" smtClean="0"/>
              <a:t>29/06/2017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69D7-F050-4ACD-8F9A-B132B5ECE3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5316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D7A80-27B7-4BC2-AA0B-1FF4A2A80187}" type="datetimeFigureOut">
              <a:rPr lang="es-ES" smtClean="0"/>
              <a:t>29/06/2017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269D7-F050-4ACD-8F9A-B132B5ECE3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8825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>
            <a:extLst>
              <a:ext uri="{FF2B5EF4-FFF2-40B4-BE49-F238E27FC236}">
                <a16:creationId xmlns:a16="http://schemas.microsoft.com/office/drawing/2014/main" id="{E8409BA3-DF29-43A8-A93A-91C9E05FEE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36309"/>
            <a:ext cx="6639339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s-E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Figure 1. Confirmatory factor analysis of selected items of Nutritional Perception Screening Questionnaire (NPSQ) in the randomised sample.</a:t>
            </a:r>
            <a:endParaRPr kumimoji="0" lang="es-ES" altLang="es-E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FB723A15-65FC-45E6-9388-3C4113C99400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77812" y="1324693"/>
            <a:ext cx="6302375" cy="47917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289578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3</Words>
  <Application>Microsoft Office PowerPoint</Application>
  <PresentationFormat>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MS Mincho</vt:lpstr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antiago Navas</dc:creator>
  <cp:lastModifiedBy>santiago Navas</cp:lastModifiedBy>
  <cp:revision>1</cp:revision>
  <dcterms:created xsi:type="dcterms:W3CDTF">2017-06-28T22:08:53Z</dcterms:created>
  <dcterms:modified xsi:type="dcterms:W3CDTF">2017-06-28T22:11:42Z</dcterms:modified>
</cp:coreProperties>
</file>